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1.jpeg" ContentType="image/jpeg"/>
  <Override PartName="/ppt/media/image20.jpeg" ContentType="image/jpeg"/>
  <Override PartName="/ppt/media/image19.jpeg" ContentType="image/jpeg"/>
  <Override PartName="/ppt/media/image42.jpeg" ContentType="image/jpeg"/>
  <Override PartName="/ppt/media/image18.jpeg" ContentType="image/jpeg"/>
  <Override PartName="/ppt/media/image17.jpeg" ContentType="image/jpeg"/>
  <Override PartName="/ppt/media/image16.jpeg" ContentType="image/jpeg"/>
  <Override PartName="/ppt/media/image15.jpeg" ContentType="image/jpeg"/>
  <Override PartName="/ppt/media/image14.jpeg" ContentType="image/jpeg"/>
  <Override PartName="/ppt/media/image41.jpeg" ContentType="image/jpeg"/>
  <Override PartName="/ppt/media/image22.jpeg" ContentType="image/jpeg"/>
  <Override PartName="/ppt/media/image1.jpeg" ContentType="image/jpeg"/>
  <Override PartName="/ppt/media/image35.jpeg" ContentType="image/jpeg"/>
  <Override PartName="/ppt/media/image23.jpeg" ContentType="image/jpeg"/>
  <Override PartName="/ppt/media/image2.jpeg" ContentType="image/jpeg"/>
  <Override PartName="/ppt/media/image36.jpeg" ContentType="image/jpeg"/>
  <Override PartName="/ppt/media/image24.jpeg" ContentType="image/jpeg"/>
  <Override PartName="/ppt/media/image3.jpeg" ContentType="image/jpeg"/>
  <Override PartName="/ppt/media/image37.jpeg" ContentType="image/jpeg"/>
  <Override PartName="/ppt/media/image25.jpeg" ContentType="image/jpeg"/>
  <Override PartName="/ppt/media/image4.jpeg" ContentType="image/jpeg"/>
  <Override PartName="/ppt/media/image26.jpeg" ContentType="image/jpeg"/>
  <Override PartName="/ppt/media/image5.jpeg" ContentType="image/jpeg"/>
  <Override PartName="/ppt/media/image33.jpeg" ContentType="image/jpeg"/>
  <Override PartName="/ppt/media/image6.jpeg" ContentType="image/jpeg"/>
  <Override PartName="/ppt/media/image34.jpeg" ContentType="image/jpeg"/>
  <Override PartName="/ppt/media/image43.jpeg" ContentType="image/jpeg"/>
  <Override PartName="/ppt/media/image44.jpeg" ContentType="image/jpeg"/>
  <Override PartName="/ppt/media/image7.jpeg" ContentType="image/jpeg"/>
  <Override PartName="/ppt/media/image38.jpeg" ContentType="image/jpeg"/>
  <Override PartName="/ppt/media/image45.jpeg" ContentType="image/jpeg"/>
  <Override PartName="/ppt/media/image46.jpeg" ContentType="image/jpeg"/>
  <Override PartName="/ppt/media/image30.jpeg" ContentType="image/jpeg"/>
  <Override PartName="/ppt/media/image47.jpeg" ContentType="image/jpeg"/>
  <Override PartName="/ppt/media/image32.jpeg" ContentType="image/jpeg"/>
  <Override PartName="/ppt/media/image49.jpeg" ContentType="image/jpeg"/>
  <Override PartName="/ppt/media/image31.jpeg" ContentType="image/jpeg"/>
  <Override PartName="/ppt/media/image48.jpeg" ContentType="image/jpeg"/>
  <Override PartName="/ppt/media/image53.jpeg" ContentType="image/jpeg"/>
  <Override PartName="/ppt/media/image9.jpeg" ContentType="image/jpeg"/>
  <Override PartName="/ppt/media/image11.jpeg" ContentType="image/jpeg"/>
  <Override PartName="/ppt/media/image40.jpeg" ContentType="image/jpeg"/>
  <Override PartName="/ppt/media/image13.jpeg" ContentType="image/jpeg"/>
  <Override PartName="/ppt/media/image28.jpeg" ContentType="image/jpeg"/>
  <Override PartName="/ppt/media/image51.jpeg" ContentType="image/jpeg"/>
  <Override PartName="/ppt/media/image39.jpeg" ContentType="image/jpeg"/>
  <Override PartName="/ppt/media/image8.jpeg" ContentType="image/jpeg"/>
  <Override PartName="/ppt/media/image10.jpeg" ContentType="image/jpeg"/>
  <Override PartName="/ppt/media/image29.jpeg" ContentType="image/jpeg"/>
  <Override PartName="/ppt/media/image52.jpeg" ContentType="image/jpeg"/>
  <Override PartName="/ppt/media/image12.jpeg" ContentType="image/jpeg"/>
  <Override PartName="/ppt/media/image27.jpeg" ContentType="image/jpeg"/>
  <Override PartName="/ppt/media/image50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D75AA4-18D8-4934-8104-90CAAB0433E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CE7E4D-D8C1-4B98-AA46-2872FD6053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6AA9E2-088B-4131-8CE3-1F46D32B2CF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E06F0F-8994-421E-8877-C8928A71580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D5C6A9-8D67-4080-8962-810173C46F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5132E1-37EC-4D28-AC48-4E10703C814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5D0025-CCC1-4B0C-B8CB-9E4E9CECB1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13394F-F96D-49F0-8261-2D8FDE62B08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2319EA-83E6-4CBE-9849-F145C97134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E3B8CC-B1E5-46AC-AE2A-C7AF2D8586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D0558C-4F16-45E8-B46C-2A0856F1BB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C8122C-DF8F-48AC-9ABE-C91BB6A7AF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A8BE3CB-E1D2-40DA-A412-1E782D18AF57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image" Target="../media/image7.jpeg"/><Relationship Id="rId3" Type="http://schemas.openxmlformats.org/officeDocument/2006/relationships/image" Target="../media/image8.jpeg"/><Relationship Id="rId4" Type="http://schemas.openxmlformats.org/officeDocument/2006/relationships/image" Target="../media/image9.jpeg"/><Relationship Id="rId5" Type="http://schemas.openxmlformats.org/officeDocument/2006/relationships/image" Target="../media/image10.jpeg"/><Relationship Id="rId6" Type="http://schemas.openxmlformats.org/officeDocument/2006/relationships/image" Target="../media/image11.jpeg"/><Relationship Id="rId7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2.jpeg"/><Relationship Id="rId2" Type="http://schemas.openxmlformats.org/officeDocument/2006/relationships/image" Target="../media/image13.jpeg"/><Relationship Id="rId3" Type="http://schemas.openxmlformats.org/officeDocument/2006/relationships/image" Target="../media/image14.jpeg"/><Relationship Id="rId4" Type="http://schemas.openxmlformats.org/officeDocument/2006/relationships/image" Target="../media/image15.jpeg"/><Relationship Id="rId5" Type="http://schemas.openxmlformats.org/officeDocument/2006/relationships/image" Target="../media/image16.jpeg"/><Relationship Id="rId6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7.jpeg"/><Relationship Id="rId2" Type="http://schemas.openxmlformats.org/officeDocument/2006/relationships/image" Target="../media/image18.jpeg"/><Relationship Id="rId3" Type="http://schemas.openxmlformats.org/officeDocument/2006/relationships/image" Target="../media/image19.jpeg"/><Relationship Id="rId4" Type="http://schemas.openxmlformats.org/officeDocument/2006/relationships/image" Target="../media/image20.jpeg"/><Relationship Id="rId5" Type="http://schemas.openxmlformats.org/officeDocument/2006/relationships/image" Target="../media/image21.jpeg"/><Relationship Id="rId6" Type="http://schemas.openxmlformats.org/officeDocument/2006/relationships/image" Target="../media/image22.jpeg"/><Relationship Id="rId7" Type="http://schemas.openxmlformats.org/officeDocument/2006/relationships/image" Target="../media/image23.jpeg"/><Relationship Id="rId8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24.jpeg"/><Relationship Id="rId2" Type="http://schemas.openxmlformats.org/officeDocument/2006/relationships/image" Target="../media/image25.jpeg"/><Relationship Id="rId3" Type="http://schemas.openxmlformats.org/officeDocument/2006/relationships/image" Target="../media/image26.jpeg"/><Relationship Id="rId4" Type="http://schemas.openxmlformats.org/officeDocument/2006/relationships/image" Target="../media/image27.jpeg"/><Relationship Id="rId5" Type="http://schemas.openxmlformats.org/officeDocument/2006/relationships/image" Target="../media/image28.jpeg"/><Relationship Id="rId6" Type="http://schemas.openxmlformats.org/officeDocument/2006/relationships/image" Target="../media/image29.jpeg"/><Relationship Id="rId7" Type="http://schemas.openxmlformats.org/officeDocument/2006/relationships/image" Target="../media/image30.jpeg"/><Relationship Id="rId8" Type="http://schemas.openxmlformats.org/officeDocument/2006/relationships/image" Target="../media/image31.jpeg"/><Relationship Id="rId9" Type="http://schemas.openxmlformats.org/officeDocument/2006/relationships/image" Target="../media/image32.jpeg"/><Relationship Id="rId10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33.jpeg"/><Relationship Id="rId2" Type="http://schemas.openxmlformats.org/officeDocument/2006/relationships/image" Target="../media/image34.jpeg"/><Relationship Id="rId3" Type="http://schemas.openxmlformats.org/officeDocument/2006/relationships/image" Target="../media/image35.jpeg"/><Relationship Id="rId4" Type="http://schemas.openxmlformats.org/officeDocument/2006/relationships/image" Target="../media/image36.jpeg"/><Relationship Id="rId5" Type="http://schemas.openxmlformats.org/officeDocument/2006/relationships/image" Target="../media/image37.jpeg"/><Relationship Id="rId6" Type="http://schemas.openxmlformats.org/officeDocument/2006/relationships/image" Target="../media/image38.jpeg"/><Relationship Id="rId7" Type="http://schemas.openxmlformats.org/officeDocument/2006/relationships/image" Target="../media/image39.jpeg"/><Relationship Id="rId8" Type="http://schemas.openxmlformats.org/officeDocument/2006/relationships/image" Target="../media/image40.jpeg"/><Relationship Id="rId9" Type="http://schemas.openxmlformats.org/officeDocument/2006/relationships/image" Target="../media/image41.jpeg"/><Relationship Id="rId10" Type="http://schemas.openxmlformats.org/officeDocument/2006/relationships/image" Target="../media/image42.jpeg"/><Relationship Id="rId11" Type="http://schemas.openxmlformats.org/officeDocument/2006/relationships/image" Target="../media/image43.jpeg"/><Relationship Id="rId1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44.jpeg"/><Relationship Id="rId2" Type="http://schemas.openxmlformats.org/officeDocument/2006/relationships/image" Target="../media/image45.jpeg"/><Relationship Id="rId3" Type="http://schemas.openxmlformats.org/officeDocument/2006/relationships/image" Target="../media/image46.jpeg"/><Relationship Id="rId4" Type="http://schemas.openxmlformats.org/officeDocument/2006/relationships/image" Target="../media/image47.jpeg"/><Relationship Id="rId5" Type="http://schemas.openxmlformats.org/officeDocument/2006/relationships/image" Target="../media/image48.jpeg"/><Relationship Id="rId6" Type="http://schemas.openxmlformats.org/officeDocument/2006/relationships/image" Target="../media/image49.jpeg"/><Relationship Id="rId7" Type="http://schemas.openxmlformats.org/officeDocument/2006/relationships/image" Target="../media/image50.jpeg"/><Relationship Id="rId8" Type="http://schemas.openxmlformats.org/officeDocument/2006/relationships/image" Target="../media/image51.jpeg"/><Relationship Id="rId9" Type="http://schemas.openxmlformats.org/officeDocument/2006/relationships/image" Target="../media/image52.jpeg"/><Relationship Id="rId10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53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9 CuadroTexto"/>
          <p:cNvSpPr/>
          <p:nvPr/>
        </p:nvSpPr>
        <p:spPr>
          <a:xfrm>
            <a:off x="856440" y="4797360"/>
            <a:ext cx="3961800" cy="61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ool 1: African  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agrestis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600" spc="-1" strike="noStrike">
                <a:solidFill>
                  <a:srgbClr val="000000"/>
                </a:solidFill>
                <a:latin typeface="Calibri"/>
              </a:rPr>
              <a:t>1-Tibish, 2-Fadasi, 3-HSD, 4-Tayer, 5-CUM 287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15 Grupo"/>
          <p:cNvGrpSpPr/>
          <p:nvPr/>
        </p:nvGrpSpPr>
        <p:grpSpPr>
          <a:xfrm>
            <a:off x="250920" y="981000"/>
            <a:ext cx="8137440" cy="3384720"/>
            <a:chOff x="250920" y="981000"/>
            <a:chExt cx="8137440" cy="3384720"/>
          </a:xfrm>
        </p:grpSpPr>
        <p:pic>
          <p:nvPicPr>
            <p:cNvPr id="43" name="Picture 1" descr="E:\Belen2octubre2011\124NIKON\fotosmelontrilateralverano2008\FOTOSCDINRA\I199-S3B\DSCN4001.JPG"/>
            <p:cNvPicPr/>
            <p:nvPr/>
          </p:nvPicPr>
          <p:blipFill>
            <a:blip r:embed="rId1"/>
            <a:srcRect l="17990" t="4460" r="10766" b="16879"/>
            <a:stretch/>
          </p:blipFill>
          <p:spPr>
            <a:xfrm>
              <a:off x="250920" y="981000"/>
              <a:ext cx="4032720" cy="3384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2" descr="E:\Belen2octubre2011\124NIKON\fotosmelontrilateralverano2008\FOTOSCDINRA\I133-1A\DSCN1915.JPG"/>
            <p:cNvPicPr/>
            <p:nvPr/>
          </p:nvPicPr>
          <p:blipFill>
            <a:blip r:embed="rId2"/>
            <a:srcRect l="19027" t="0" r="19027" b="21030"/>
            <a:stretch/>
          </p:blipFill>
          <p:spPr>
            <a:xfrm>
              <a:off x="4283640" y="981000"/>
              <a:ext cx="1962720" cy="1872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3" descr="E:\Belen2octubre2011\124NIKON\fotosmelontrilateralverano2008\FOTOSCDINRA\I145-1A\DSCN1921.JPG"/>
            <p:cNvPicPr/>
            <p:nvPr/>
          </p:nvPicPr>
          <p:blipFill>
            <a:blip r:embed="rId3"/>
            <a:srcRect l="16956" t="0" r="9736" b="12747"/>
            <a:stretch/>
          </p:blipFill>
          <p:spPr>
            <a:xfrm>
              <a:off x="6228000" y="981000"/>
              <a:ext cx="2160360" cy="1924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Picture 4" descr="E:\Belen2octubre2011\124NIKON\fotosmelontrilateralverano2008\FOTOSCDINRA\I195-2A\DSCN1235.JPG"/>
            <p:cNvPicPr/>
            <p:nvPr/>
          </p:nvPicPr>
          <p:blipFill>
            <a:blip r:embed="rId4"/>
            <a:srcRect l="14890" t="12737" r="12830" b="26550"/>
            <a:stretch/>
          </p:blipFill>
          <p:spPr>
            <a:xfrm>
              <a:off x="4283640" y="2853360"/>
              <a:ext cx="2160360" cy="1512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Picture 5" descr="E:\Belen2octubre2011\124NIKON\fotosmelontrilateralverano2008\FOTOS FRUTOS PARA CD\C38-3A\DSCN1561.JPG"/>
            <p:cNvPicPr/>
            <p:nvPr/>
          </p:nvPicPr>
          <p:blipFill>
            <a:blip r:embed="rId5"/>
            <a:srcRect l="8702" t="0" r="15925" b="23788"/>
            <a:stretch/>
          </p:blipFill>
          <p:spPr>
            <a:xfrm>
              <a:off x="6372000" y="2853360"/>
              <a:ext cx="2016360" cy="1512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8" name="10 CuadroTexto"/>
            <p:cNvSpPr/>
            <p:nvPr/>
          </p:nvSpPr>
          <p:spPr>
            <a:xfrm>
              <a:off x="325440" y="1053000"/>
              <a:ext cx="296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11 CuadroTexto"/>
            <p:cNvSpPr/>
            <p:nvPr/>
          </p:nvSpPr>
          <p:spPr>
            <a:xfrm>
              <a:off x="4286160" y="1053000"/>
              <a:ext cx="296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12 CuadroTexto"/>
            <p:cNvSpPr/>
            <p:nvPr/>
          </p:nvSpPr>
          <p:spPr>
            <a:xfrm>
              <a:off x="6302520" y="1053000"/>
              <a:ext cx="296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13 CuadroTexto"/>
            <p:cNvSpPr/>
            <p:nvPr/>
          </p:nvSpPr>
          <p:spPr>
            <a:xfrm>
              <a:off x="4286160" y="2853360"/>
              <a:ext cx="296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4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14 CuadroTexto"/>
            <p:cNvSpPr/>
            <p:nvPr/>
          </p:nvSpPr>
          <p:spPr>
            <a:xfrm>
              <a:off x="6446520" y="2853360"/>
              <a:ext cx="296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5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3 Rectángulo"/>
          <p:cNvSpPr/>
          <p:nvPr/>
        </p:nvSpPr>
        <p:spPr>
          <a:xfrm>
            <a:off x="755640" y="5084640"/>
            <a:ext cx="7602480" cy="61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ool 2: Asian 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agrestis- acidulus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6-Wild Chibbar, 7-SLK, 8-Meloncito, 9-TGR1551, 10-Voatango, 11-Ary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4" name="16 Grupo"/>
          <p:cNvGrpSpPr/>
          <p:nvPr/>
        </p:nvGrpSpPr>
        <p:grpSpPr>
          <a:xfrm>
            <a:off x="468360" y="476280"/>
            <a:ext cx="8437680" cy="4392720"/>
            <a:chOff x="468360" y="476280"/>
            <a:chExt cx="8437680" cy="4392720"/>
          </a:xfrm>
        </p:grpSpPr>
        <p:pic>
          <p:nvPicPr>
            <p:cNvPr id="55" name="Picture 2" descr="E:\Belen2octubre2011\124NIKON\fotosmelontrilateralverano2008\FOTOSCDINRA\I204-2C\DSCN1275.JPG"/>
            <p:cNvPicPr/>
            <p:nvPr/>
          </p:nvPicPr>
          <p:blipFill>
            <a:blip r:embed="rId1"/>
            <a:srcRect l="15932" t="0" r="22127" b="22399"/>
            <a:stretch/>
          </p:blipFill>
          <p:spPr>
            <a:xfrm>
              <a:off x="468360" y="476280"/>
              <a:ext cx="2260080" cy="2118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6" name="Picture 3" descr="E:\Belen2octubre2011\124NIKON\fotosmelontrilateralverano2008\FOTOSCDINRA\I187-3A\DSCN2226.JPG"/>
            <p:cNvPicPr/>
            <p:nvPr/>
          </p:nvPicPr>
          <p:blipFill>
            <a:blip r:embed="rId2"/>
            <a:srcRect l="9728" t="0" r="7667" b="18259"/>
            <a:stretch/>
          </p:blipFill>
          <p:spPr>
            <a:xfrm>
              <a:off x="2700360" y="476280"/>
              <a:ext cx="2843640" cy="210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7" name="Picture 4" descr="E:\Belen2octubre2011\124NIKON\fotosmelontrilateralverano2008\FOTOSCDINRA\I153-3A\DSCN1703.JPG"/>
            <p:cNvPicPr/>
            <p:nvPr/>
          </p:nvPicPr>
          <p:blipFill>
            <a:blip r:embed="rId3"/>
            <a:srcRect l="8722" t="8742" r="8393" b="24214"/>
            <a:stretch/>
          </p:blipFill>
          <p:spPr>
            <a:xfrm>
              <a:off x="5456160" y="476280"/>
              <a:ext cx="3449880" cy="2088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8" name="Picture 5" descr="E:\Belen2octubre2011\124NIKON\fotosmelontrilateralverano2008\FOTOSCDINRA\I115-2B\DSCN0275.JPG"/>
            <p:cNvPicPr/>
            <p:nvPr/>
          </p:nvPicPr>
          <p:blipFill>
            <a:blip r:embed="rId4"/>
            <a:srcRect l="10255" t="40340" r="51033" b="10965"/>
            <a:stretch/>
          </p:blipFill>
          <p:spPr>
            <a:xfrm>
              <a:off x="6444360" y="2564640"/>
              <a:ext cx="2448000" cy="2304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" name="Picture 6" descr="E:\Belen2octubre2011\124NIKON\fotosmelontrilateralverano2008\FOTOS FRUTOS PARA CD\C100-2A\DSCN2039.JPG"/>
            <p:cNvPicPr/>
            <p:nvPr/>
          </p:nvPicPr>
          <p:blipFill>
            <a:blip r:embed="rId5"/>
            <a:srcRect l="6926" t="3902" r="5448" b="23886"/>
            <a:stretch/>
          </p:blipFill>
          <p:spPr>
            <a:xfrm>
              <a:off x="468360" y="2564640"/>
              <a:ext cx="3672000" cy="2304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" name="Picture 7" descr="E:\Belen2octubre2011\124NIKON\fotosmelontrilateralverano2008\FOTOSCDINRA\I202-3A\DSCN2211.JPG"/>
            <p:cNvPicPr/>
            <p:nvPr/>
          </p:nvPicPr>
          <p:blipFill>
            <a:blip r:embed="rId6"/>
            <a:srcRect l="24187" t="7225" r="11794" b="11358"/>
            <a:stretch/>
          </p:blipFill>
          <p:spPr>
            <a:xfrm>
              <a:off x="4140360" y="2564640"/>
              <a:ext cx="2345400" cy="2304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1" name="10 CuadroTexto"/>
            <p:cNvSpPr/>
            <p:nvPr/>
          </p:nvSpPr>
          <p:spPr>
            <a:xfrm>
              <a:off x="542520" y="548280"/>
              <a:ext cx="296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6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11 CuadroTexto"/>
            <p:cNvSpPr/>
            <p:nvPr/>
          </p:nvSpPr>
          <p:spPr>
            <a:xfrm>
              <a:off x="542520" y="2636640"/>
              <a:ext cx="296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9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12 CuadroTexto"/>
            <p:cNvSpPr/>
            <p:nvPr/>
          </p:nvSpPr>
          <p:spPr>
            <a:xfrm>
              <a:off x="5510520" y="548280"/>
              <a:ext cx="296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8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13 CuadroTexto"/>
            <p:cNvSpPr/>
            <p:nvPr/>
          </p:nvSpPr>
          <p:spPr>
            <a:xfrm>
              <a:off x="2774520" y="548280"/>
              <a:ext cx="296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7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14 CuadroTexto"/>
            <p:cNvSpPr/>
            <p:nvPr/>
          </p:nvSpPr>
          <p:spPr>
            <a:xfrm>
              <a:off x="4143600" y="2636640"/>
              <a:ext cx="412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1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15 CuadroTexto"/>
            <p:cNvSpPr/>
            <p:nvPr/>
          </p:nvSpPr>
          <p:spPr>
            <a:xfrm>
              <a:off x="6591600" y="2636640"/>
              <a:ext cx="412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1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3 Rectángulo"/>
          <p:cNvSpPr/>
          <p:nvPr/>
        </p:nvSpPr>
        <p:spPr>
          <a:xfrm>
            <a:off x="539640" y="5616720"/>
            <a:ext cx="8390160" cy="61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ool 3: Far East  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conom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12-Pat 81, 13-Freeman´s cucumber, 14-Songwhan Charmi, 15-Nabunkin, 16-Pau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8" name="14 Grupo"/>
          <p:cNvGrpSpPr/>
          <p:nvPr/>
        </p:nvGrpSpPr>
        <p:grpSpPr>
          <a:xfrm>
            <a:off x="250920" y="765000"/>
            <a:ext cx="8642160" cy="4543560"/>
            <a:chOff x="250920" y="765000"/>
            <a:chExt cx="8642160" cy="4543560"/>
          </a:xfrm>
        </p:grpSpPr>
        <p:pic>
          <p:nvPicPr>
            <p:cNvPr id="69" name="Picture 2" descr="E:\Belen2octubre2011\124NIKON\fotosmelontrilateralverano2008\FOTOSCDINRA\I136-2B\DSCN0842.JPG"/>
            <p:cNvPicPr/>
            <p:nvPr/>
          </p:nvPicPr>
          <p:blipFill>
            <a:blip r:embed="rId1"/>
            <a:srcRect l="15490" t="5524" r="11201" b="12749"/>
            <a:stretch/>
          </p:blipFill>
          <p:spPr>
            <a:xfrm>
              <a:off x="2987640" y="765000"/>
              <a:ext cx="2880720" cy="2231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0" name="Picture 3" descr="E:\Belen2octubre2011\124NIKON\fotosmelontrilateralverano2008\FOTOSCDINRA\I173-S3A\DSCN2627.JPG"/>
            <p:cNvPicPr/>
            <p:nvPr/>
          </p:nvPicPr>
          <p:blipFill>
            <a:blip r:embed="rId2"/>
            <a:srcRect l="17995" t="9981" r="9729" b="22406"/>
            <a:stretch/>
          </p:blipFill>
          <p:spPr>
            <a:xfrm>
              <a:off x="5796360" y="765000"/>
              <a:ext cx="3096720" cy="2231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1" name="Picture 4" descr="E:\Belen2octubre2011\124NIKON\fotosmelontrilateralverano2008\FOTOSCDINRA\I158-1A\DSCN0283.JPG"/>
            <p:cNvPicPr/>
            <p:nvPr/>
          </p:nvPicPr>
          <p:blipFill>
            <a:blip r:embed="rId3"/>
            <a:srcRect l="3539" t="9979" r="8696" b="29302"/>
            <a:stretch/>
          </p:blipFill>
          <p:spPr>
            <a:xfrm>
              <a:off x="250920" y="3000240"/>
              <a:ext cx="4609080" cy="2308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2" name="Picture 5" descr="E:\Belen2octubre2011\124NIKON\fotosmelontrilateralverano2008\FOTOSCDINRA\I169-S1B\DSCN2415.JPG"/>
            <p:cNvPicPr/>
            <p:nvPr/>
          </p:nvPicPr>
          <p:blipFill>
            <a:blip r:embed="rId4"/>
            <a:srcRect l="3539" t="8597" r="0" b="11359"/>
            <a:stretch/>
          </p:blipFill>
          <p:spPr>
            <a:xfrm>
              <a:off x="4860000" y="2996640"/>
              <a:ext cx="4033080" cy="230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3" name="Picture 6" descr="E:\Belen2octubre2011\124NIKON\fotosmelontrilateralverano2008\FOTOS FRUTOS PARA CD\C32-2A\DSCN0524.JPG"/>
            <p:cNvPicPr/>
            <p:nvPr/>
          </p:nvPicPr>
          <p:blipFill>
            <a:blip r:embed="rId5"/>
            <a:srcRect l="13866" t="1695" r="8701" b="15508"/>
            <a:stretch/>
          </p:blipFill>
          <p:spPr>
            <a:xfrm>
              <a:off x="250920" y="765000"/>
              <a:ext cx="2790720" cy="2231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4" name="9 CuadroTexto"/>
            <p:cNvSpPr/>
            <p:nvPr/>
          </p:nvSpPr>
          <p:spPr>
            <a:xfrm>
              <a:off x="254160" y="765000"/>
              <a:ext cx="412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1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10 CuadroTexto"/>
            <p:cNvSpPr/>
            <p:nvPr/>
          </p:nvSpPr>
          <p:spPr>
            <a:xfrm>
              <a:off x="3062880" y="836640"/>
              <a:ext cx="412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1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11 CuadroTexto"/>
            <p:cNvSpPr/>
            <p:nvPr/>
          </p:nvSpPr>
          <p:spPr>
            <a:xfrm>
              <a:off x="5871600" y="836640"/>
              <a:ext cx="412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14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12 CuadroTexto"/>
            <p:cNvSpPr/>
            <p:nvPr/>
          </p:nvSpPr>
          <p:spPr>
            <a:xfrm>
              <a:off x="254160" y="3140640"/>
              <a:ext cx="412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15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13 CuadroTexto"/>
            <p:cNvSpPr/>
            <p:nvPr/>
          </p:nvSpPr>
          <p:spPr>
            <a:xfrm>
              <a:off x="4935240" y="3068640"/>
              <a:ext cx="412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16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3 Rectángulo"/>
          <p:cNvSpPr/>
          <p:nvPr/>
        </p:nvSpPr>
        <p:spPr>
          <a:xfrm>
            <a:off x="250920" y="4508640"/>
            <a:ext cx="7250040" cy="885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ool 4: Middle East and Indian 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momordica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, 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dudaim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and 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flexuosu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17-PI 124112, 18-MR-1, 19- CUM 438, 20-Snake melon , 21-CUM353, 22-CUM225, 23-Queen´s pocket mel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0" name="20 Grupo"/>
          <p:cNvGrpSpPr/>
          <p:nvPr/>
        </p:nvGrpSpPr>
        <p:grpSpPr>
          <a:xfrm>
            <a:off x="142560" y="907920"/>
            <a:ext cx="8893440" cy="3178440"/>
            <a:chOff x="142560" y="907920"/>
            <a:chExt cx="8893440" cy="3178440"/>
          </a:xfrm>
        </p:grpSpPr>
        <p:pic>
          <p:nvPicPr>
            <p:cNvPr id="81" name="Picture 2" descr="E:\Belen2octubre2011\124NIKON\fotosmelontrilateralverano2008\FOTOSCDINRA\I155-2A\DSCN0976.JPG"/>
            <p:cNvPicPr/>
            <p:nvPr/>
          </p:nvPicPr>
          <p:blipFill>
            <a:blip r:embed="rId1"/>
            <a:srcRect l="4574" t="11370" r="2503" b="22401"/>
            <a:stretch/>
          </p:blipFill>
          <p:spPr>
            <a:xfrm>
              <a:off x="2571840" y="979920"/>
              <a:ext cx="3168360" cy="169020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82" name="19 Grupo"/>
            <p:cNvGrpSpPr/>
            <p:nvPr/>
          </p:nvGrpSpPr>
          <p:grpSpPr>
            <a:xfrm>
              <a:off x="142560" y="907920"/>
              <a:ext cx="8893440" cy="3178440"/>
              <a:chOff x="142560" y="907920"/>
              <a:chExt cx="8893440" cy="3178440"/>
            </a:xfrm>
          </p:grpSpPr>
          <p:pic>
            <p:nvPicPr>
              <p:cNvPr id="83" name="Picture 1" descr="E:\Belen2octubre2011\124NIKON\fotosmelontrilateralverano2008\FOTOS FRUTOS PARA CD\C21-3A\DSCN1434.JPG"/>
              <p:cNvPicPr/>
              <p:nvPr/>
            </p:nvPicPr>
            <p:blipFill>
              <a:blip r:embed="rId2"/>
              <a:stretch/>
            </p:blipFill>
            <p:spPr>
              <a:xfrm rot="5400000">
                <a:off x="522000" y="600120"/>
                <a:ext cx="1689480" cy="2448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4" name="Picture 3" descr="E:\Belen2octubre2011\124NIKON\fotosmelontrilateralverano2008\FOTOSCDINRA\I188-2B\DSCN0892.JPG"/>
              <p:cNvPicPr/>
              <p:nvPr/>
            </p:nvPicPr>
            <p:blipFill>
              <a:blip r:embed="rId3"/>
              <a:srcRect l="1468" t="27932" r="11804" b="7218"/>
              <a:stretch/>
            </p:blipFill>
            <p:spPr>
              <a:xfrm>
                <a:off x="142920" y="2636640"/>
                <a:ext cx="2574000" cy="1440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5" name="Picture 4" descr="E:\Belen2octubre2011\124NIKON\fotosmelontrilateralverano2008\FOTOS FRUTOS PARA CD\C24´-1A\DSCN1734.JPG"/>
              <p:cNvPicPr/>
              <p:nvPr/>
            </p:nvPicPr>
            <p:blipFill>
              <a:blip r:embed="rId4"/>
              <a:srcRect l="7671" t="321" r="15921" b="25170"/>
              <a:stretch/>
            </p:blipFill>
            <p:spPr>
              <a:xfrm>
                <a:off x="2591280" y="2662200"/>
                <a:ext cx="1944360" cy="14191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6" name="Picture 5" descr="E:\Belen2octubre2011\124NIKON\fotosmelontrilateralverano2008\FOTOSCDINRA\I180-2A\DSCN0726.JPG"/>
              <p:cNvPicPr/>
              <p:nvPr/>
            </p:nvPicPr>
            <p:blipFill>
              <a:blip r:embed="rId5"/>
              <a:srcRect l="5605" t="8595" r="0" b="25170"/>
              <a:stretch/>
            </p:blipFill>
            <p:spPr>
              <a:xfrm>
                <a:off x="6299640" y="2649240"/>
                <a:ext cx="2736360" cy="14371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7" name="Picture 6" descr="E:\Belen2octubre2011\124NIKON\fotosmelontrilateralverano2008\FOTOS FRUTOS PARA CD\C19-6B\DSCN1052.JPG"/>
              <p:cNvPicPr/>
              <p:nvPr/>
            </p:nvPicPr>
            <p:blipFill>
              <a:blip r:embed="rId6"/>
              <a:srcRect l="4128" t="11047" r="0" b="19648"/>
              <a:stretch/>
            </p:blipFill>
            <p:spPr>
              <a:xfrm>
                <a:off x="5723280" y="979920"/>
                <a:ext cx="3312720" cy="16754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8" name="Picture 7" descr="E:\Belen2octubre2011\124NIKON\fotosmelontrilateralverano2008\FOTOS FRUTOS PARA CD\C20-1B\DSCN0601.JPG"/>
              <p:cNvPicPr/>
              <p:nvPr/>
            </p:nvPicPr>
            <p:blipFill>
              <a:blip r:embed="rId7"/>
              <a:srcRect l="12834" t="-4204" r="6638" b="15505"/>
              <a:stretch/>
            </p:blipFill>
            <p:spPr>
              <a:xfrm>
                <a:off x="4463640" y="2564640"/>
                <a:ext cx="1835640" cy="15134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9" name="12 CuadroTexto"/>
              <p:cNvSpPr/>
              <p:nvPr/>
            </p:nvSpPr>
            <p:spPr>
              <a:xfrm>
                <a:off x="146160" y="907920"/>
                <a:ext cx="4122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800" spc="-1" strike="noStrike">
                    <a:solidFill>
                      <a:srgbClr val="ffffff"/>
                    </a:solidFill>
                    <a:latin typeface="Calibri"/>
                  </a:rPr>
                  <a:t>17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13 CuadroTexto"/>
              <p:cNvSpPr/>
              <p:nvPr/>
            </p:nvSpPr>
            <p:spPr>
              <a:xfrm>
                <a:off x="5763240" y="979920"/>
                <a:ext cx="4122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800" spc="-1" strike="noStrike">
                    <a:solidFill>
                      <a:srgbClr val="ffffff"/>
                    </a:solidFill>
                    <a:latin typeface="Calibri"/>
                  </a:rPr>
                  <a:t>19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14 CuadroTexto"/>
              <p:cNvSpPr/>
              <p:nvPr/>
            </p:nvSpPr>
            <p:spPr>
              <a:xfrm>
                <a:off x="2666520" y="979920"/>
                <a:ext cx="4122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800" spc="-1" strike="noStrike">
                    <a:solidFill>
                      <a:srgbClr val="ffffff"/>
                    </a:solidFill>
                    <a:latin typeface="Calibri"/>
                  </a:rPr>
                  <a:t>18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15 CuadroTexto"/>
              <p:cNvSpPr/>
              <p:nvPr/>
            </p:nvSpPr>
            <p:spPr>
              <a:xfrm>
                <a:off x="3746880" y="2636640"/>
                <a:ext cx="4122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800" spc="-1" strike="noStrike">
                    <a:solidFill>
                      <a:srgbClr val="ffffff"/>
                    </a:solidFill>
                    <a:latin typeface="Calibri"/>
                  </a:rPr>
                  <a:t>21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16 CuadroTexto"/>
              <p:cNvSpPr/>
              <p:nvPr/>
            </p:nvSpPr>
            <p:spPr>
              <a:xfrm>
                <a:off x="146160" y="2492640"/>
                <a:ext cx="4122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800" spc="-1" strike="noStrike">
                    <a:solidFill>
                      <a:srgbClr val="ffffff"/>
                    </a:solidFill>
                    <a:latin typeface="Calibri"/>
                  </a:rPr>
                  <a:t>20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17 CuadroTexto"/>
              <p:cNvSpPr/>
              <p:nvPr/>
            </p:nvSpPr>
            <p:spPr>
              <a:xfrm>
                <a:off x="5403240" y="2636640"/>
                <a:ext cx="4122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800" spc="-1" strike="noStrike">
                    <a:solidFill>
                      <a:srgbClr val="ffffff"/>
                    </a:solidFill>
                    <a:latin typeface="Calibri"/>
                  </a:rPr>
                  <a:t>22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18 CuadroTexto"/>
              <p:cNvSpPr/>
              <p:nvPr/>
            </p:nvSpPr>
            <p:spPr>
              <a:xfrm>
                <a:off x="6339240" y="2636640"/>
                <a:ext cx="4122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800" spc="-1" strike="noStrike">
                    <a:solidFill>
                      <a:srgbClr val="ffffff"/>
                    </a:solidFill>
                    <a:latin typeface="Calibri"/>
                  </a:rPr>
                  <a:t>23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3 Rectángulo"/>
          <p:cNvSpPr/>
          <p:nvPr/>
        </p:nvSpPr>
        <p:spPr>
          <a:xfrm>
            <a:off x="324000" y="5732640"/>
            <a:ext cx="7891200" cy="10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ool 5: Group 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cantalupensi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24-Noy Israel, 25-Noir des carmes, 26-Presscott fond blanc, 27-Topmark, 28-Nantais Oblong, 29 Gynadou, 30-Cantalup dálger, 31-PMR45, 32-36-S. Fitó Charentais (an example of the Charentais market class is shown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AutoShape 8"/>
          <p:cNvSpPr/>
          <p:nvPr/>
        </p:nvSpPr>
        <p:spPr>
          <a:xfrm>
            <a:off x="63360" y="-136440"/>
            <a:ext cx="304920" cy="30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AutoShape 10"/>
          <p:cNvSpPr/>
          <p:nvPr/>
        </p:nvSpPr>
        <p:spPr>
          <a:xfrm>
            <a:off x="63360" y="-136440"/>
            <a:ext cx="304920" cy="30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9" name="27 Grupo"/>
          <p:cNvGrpSpPr/>
          <p:nvPr/>
        </p:nvGrpSpPr>
        <p:grpSpPr>
          <a:xfrm>
            <a:off x="250920" y="857160"/>
            <a:ext cx="8569080" cy="4630680"/>
            <a:chOff x="250920" y="857160"/>
            <a:chExt cx="8569080" cy="4630680"/>
          </a:xfrm>
        </p:grpSpPr>
        <p:pic>
          <p:nvPicPr>
            <p:cNvPr id="100" name="Picture 12" descr="E:\Belen2octubre2011\124NIKON\fotosmelontrilateralverano2008\FOTOSCDINRA\I129-2A\DSCN1891.JPG"/>
            <p:cNvPicPr/>
            <p:nvPr/>
          </p:nvPicPr>
          <p:blipFill>
            <a:blip r:embed="rId1"/>
            <a:srcRect l="0" t="8601" r="5605" b="19649"/>
            <a:stretch/>
          </p:blipFill>
          <p:spPr>
            <a:xfrm>
              <a:off x="2856960" y="3714840"/>
              <a:ext cx="3024360" cy="1773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1" name="19 CuadroTexto"/>
            <p:cNvSpPr/>
            <p:nvPr/>
          </p:nvSpPr>
          <p:spPr>
            <a:xfrm>
              <a:off x="2918520" y="3861000"/>
              <a:ext cx="412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3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2" name="25 Grupo"/>
            <p:cNvGrpSpPr/>
            <p:nvPr/>
          </p:nvGrpSpPr>
          <p:grpSpPr>
            <a:xfrm>
              <a:off x="250920" y="857160"/>
              <a:ext cx="8569080" cy="4630680"/>
              <a:chOff x="250920" y="857160"/>
              <a:chExt cx="8569080" cy="4630680"/>
            </a:xfrm>
          </p:grpSpPr>
          <p:pic>
            <p:nvPicPr>
              <p:cNvPr id="103" name="Picture 1" descr="E:\Belen2octubre2011\124NIKON\fotosmelontrilateralverano2008\FOTOSCDINRA\I162-2A\DSCN1293.JPG"/>
              <p:cNvPicPr/>
              <p:nvPr/>
            </p:nvPicPr>
            <p:blipFill>
              <a:blip r:embed="rId2"/>
              <a:srcRect l="1465" t="7230" r="0" b="21031"/>
              <a:stretch/>
            </p:blipFill>
            <p:spPr>
              <a:xfrm>
                <a:off x="250920" y="857160"/>
                <a:ext cx="2811240" cy="15318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4" name="Picture 2" descr="E:\Belen2octubre2011\124NIKON\fotosmelontrilateralverano2008\FOTOSCDINRA\I161-3A\DSCN0901.JPG"/>
              <p:cNvPicPr/>
              <p:nvPr/>
            </p:nvPicPr>
            <p:blipFill>
              <a:blip r:embed="rId3"/>
              <a:srcRect l="0" t="8595" r="0" b="21028"/>
              <a:stretch/>
            </p:blipFill>
            <p:spPr>
              <a:xfrm>
                <a:off x="3059280" y="857160"/>
                <a:ext cx="2880360" cy="15166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5" name="Picture 3" descr="E:\Belen2octubre2011\124NIKON\fotosmelontrilateralverano2008\FOTOSCDINRA\I179-3A\DSCN0527.JPG"/>
              <p:cNvPicPr/>
              <p:nvPr/>
            </p:nvPicPr>
            <p:blipFill>
              <a:blip r:embed="rId4"/>
              <a:srcRect l="6631" t="15507" r="0" b="23779"/>
              <a:stretch/>
            </p:blipFill>
            <p:spPr>
              <a:xfrm>
                <a:off x="5901120" y="857160"/>
                <a:ext cx="2915640" cy="15177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6" name="Picture 4" descr="E:\Belen2octubre2011\124NIKON\fotosmelontrilateralverano2008\FOTOS FRUTOS PARA CD\C94-2A\DSCN1987.JPG"/>
              <p:cNvPicPr/>
              <p:nvPr/>
            </p:nvPicPr>
            <p:blipFill>
              <a:blip r:embed="rId5"/>
              <a:srcRect l="0" t="12735" r="0" b="21020"/>
              <a:stretch/>
            </p:blipFill>
            <p:spPr>
              <a:xfrm>
                <a:off x="250920" y="2369160"/>
                <a:ext cx="2952360" cy="13917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7" name="Picture 5" descr="E:\Belen2octubre2011\124NIKON\fotosmelontrilateralverano2008\FOTOSCDINRA\I159-1A\DSCN1346.JPG"/>
              <p:cNvPicPr/>
              <p:nvPr/>
            </p:nvPicPr>
            <p:blipFill>
              <a:blip r:embed="rId6"/>
              <a:srcRect l="0" t="7228" r="0" b="21023"/>
              <a:stretch/>
            </p:blipFill>
            <p:spPr>
              <a:xfrm>
                <a:off x="3203280" y="2369160"/>
                <a:ext cx="2808360" cy="13680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8" name="Picture 6" descr="E:\Belen2octubre2011\124NIKON\fotosmelontrilateralverano2008\FOTOSCDINRA\I141-3A\DSCN1980.JPG"/>
              <p:cNvPicPr/>
              <p:nvPr/>
            </p:nvPicPr>
            <p:blipFill>
              <a:blip r:embed="rId7"/>
              <a:srcRect l="0" t="0" r="0" b="12754"/>
              <a:stretch/>
            </p:blipFill>
            <p:spPr>
              <a:xfrm>
                <a:off x="6011640" y="2369160"/>
                <a:ext cx="2808360" cy="13680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9" name="Picture 11" descr="E:\Belen2octubre2011\124NIKON\fotosmelontrilateralverano2008\FOTOSCDINRA\I165-1A\DSCN1717.JPG"/>
              <p:cNvPicPr/>
              <p:nvPr/>
            </p:nvPicPr>
            <p:blipFill>
              <a:blip r:embed="rId8"/>
              <a:srcRect l="11795" t="3090" r="7671" b="12741"/>
              <a:stretch/>
            </p:blipFill>
            <p:spPr>
              <a:xfrm>
                <a:off x="250920" y="3737520"/>
                <a:ext cx="2664360" cy="17449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10" name="15 CuadroTexto"/>
              <p:cNvSpPr/>
              <p:nvPr/>
            </p:nvSpPr>
            <p:spPr>
              <a:xfrm>
                <a:off x="250920" y="929160"/>
                <a:ext cx="4186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800" spc="-1" strike="noStrike">
                    <a:solidFill>
                      <a:srgbClr val="ffffff"/>
                    </a:solidFill>
                    <a:latin typeface="Calibri"/>
                  </a:rPr>
                  <a:t>24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18 CuadroTexto"/>
              <p:cNvSpPr/>
              <p:nvPr/>
            </p:nvSpPr>
            <p:spPr>
              <a:xfrm>
                <a:off x="254160" y="3737520"/>
                <a:ext cx="4122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800" spc="-1" strike="noStrike">
                    <a:solidFill>
                      <a:srgbClr val="ffffff"/>
                    </a:solidFill>
                    <a:latin typeface="Calibri"/>
                  </a:rPr>
                  <a:t>30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20 CuadroTexto"/>
              <p:cNvSpPr/>
              <p:nvPr/>
            </p:nvSpPr>
            <p:spPr>
              <a:xfrm>
                <a:off x="6014880" y="2297160"/>
                <a:ext cx="4122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800" spc="-1" strike="noStrike">
                    <a:solidFill>
                      <a:srgbClr val="ffffff"/>
                    </a:solidFill>
                    <a:latin typeface="Calibri"/>
                  </a:rPr>
                  <a:t>29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21 CuadroTexto"/>
              <p:cNvSpPr/>
              <p:nvPr/>
            </p:nvSpPr>
            <p:spPr>
              <a:xfrm>
                <a:off x="3134520" y="2297160"/>
                <a:ext cx="4122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800" spc="-1" strike="noStrike">
                    <a:solidFill>
                      <a:srgbClr val="ffffff"/>
                    </a:solidFill>
                    <a:latin typeface="Calibri"/>
                  </a:rPr>
                  <a:t>28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22 CuadroTexto"/>
              <p:cNvSpPr/>
              <p:nvPr/>
            </p:nvSpPr>
            <p:spPr>
              <a:xfrm>
                <a:off x="254160" y="2297160"/>
                <a:ext cx="4122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800" spc="-1" strike="noStrike">
                    <a:solidFill>
                      <a:srgbClr val="ffffff"/>
                    </a:solidFill>
                    <a:latin typeface="Calibri"/>
                  </a:rPr>
                  <a:t>27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23 CuadroTexto"/>
              <p:cNvSpPr/>
              <p:nvPr/>
            </p:nvSpPr>
            <p:spPr>
              <a:xfrm>
                <a:off x="3062520" y="857160"/>
                <a:ext cx="4122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800" spc="-1" strike="noStrike">
                    <a:solidFill>
                      <a:srgbClr val="ffffff"/>
                    </a:solidFill>
                    <a:latin typeface="Calibri"/>
                  </a:rPr>
                  <a:t>25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24 CuadroTexto"/>
              <p:cNvSpPr/>
              <p:nvPr/>
            </p:nvSpPr>
            <p:spPr>
              <a:xfrm>
                <a:off x="6014880" y="857160"/>
                <a:ext cx="4122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800" spc="-1" strike="noStrike">
                    <a:solidFill>
                      <a:srgbClr val="ffffff"/>
                    </a:solidFill>
                    <a:latin typeface="Calibri"/>
                  </a:rPr>
                  <a:t>26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17" name="Picture 13" descr="E:\Belen2octubre2011\124NIKON\fotosmelontrilateralverano2008\FOTOS_FRUTOS1\I201-2A\DSCN0730.JPG"/>
              <p:cNvPicPr/>
              <p:nvPr/>
            </p:nvPicPr>
            <p:blipFill>
              <a:blip r:embed="rId9"/>
              <a:srcRect l="0" t="11366" r="0" b="21028"/>
              <a:stretch/>
            </p:blipFill>
            <p:spPr>
              <a:xfrm>
                <a:off x="5821560" y="3711960"/>
                <a:ext cx="2988720" cy="1775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18" name="26 CuadroTexto"/>
              <p:cNvSpPr/>
              <p:nvPr/>
            </p:nvSpPr>
            <p:spPr>
              <a:xfrm>
                <a:off x="5943960" y="3737520"/>
                <a:ext cx="7142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800" spc="-1" strike="noStrike">
                    <a:solidFill>
                      <a:srgbClr val="ffffff"/>
                    </a:solidFill>
                    <a:latin typeface="Calibri"/>
                  </a:rPr>
                  <a:t>32-36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3 Rectángulo"/>
          <p:cNvSpPr/>
          <p:nvPr/>
        </p:nvSpPr>
        <p:spPr>
          <a:xfrm>
            <a:off x="142920" y="4862520"/>
            <a:ext cx="8429760" cy="855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ool 6: Group 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melo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Eastern Europe, Central Asia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, inodorus, chandalack, ameri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37-Honeydew, 38-Kirkagac, 39-Muchanesvi, 40-Baskavas, 41-Korca, 42-Kiziluruk, 43-Hami melon, 44-Winter type, 45-Maazoon, 46-Blanco, 47-Carosello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0" name="27 Grupo"/>
          <p:cNvGrpSpPr/>
          <p:nvPr/>
        </p:nvGrpSpPr>
        <p:grpSpPr>
          <a:xfrm>
            <a:off x="179280" y="549360"/>
            <a:ext cx="8209080" cy="4271760"/>
            <a:chOff x="179280" y="549360"/>
            <a:chExt cx="8209080" cy="4271760"/>
          </a:xfrm>
        </p:grpSpPr>
        <p:pic>
          <p:nvPicPr>
            <p:cNvPr id="121" name="Picture 1" descr="E:\Belen2octubre2011\124NIKON\fotosmelontrilateralverano2008\FOTOS_FRUTOS1\I143-1B\DSCN1464.JPG"/>
            <p:cNvPicPr/>
            <p:nvPr/>
          </p:nvPicPr>
          <p:blipFill>
            <a:blip r:embed="rId1"/>
            <a:srcRect l="2504" t="14119" r="5599" b="21024"/>
            <a:stretch/>
          </p:blipFill>
          <p:spPr>
            <a:xfrm>
              <a:off x="179280" y="549360"/>
              <a:ext cx="3024360" cy="1596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2" name="Picture 2" descr="E:\Belen2octubre2011\124NIKON\fotosmelontrilateralverano2008\FOTOS_FRUTOS1\I150-3A\DSCN2051.JPG"/>
            <p:cNvPicPr/>
            <p:nvPr/>
          </p:nvPicPr>
          <p:blipFill>
            <a:blip r:embed="rId2"/>
            <a:srcRect l="0" t="5844" r="0" b="23791"/>
            <a:stretch/>
          </p:blipFill>
          <p:spPr>
            <a:xfrm>
              <a:off x="3203640" y="549360"/>
              <a:ext cx="3008160" cy="158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3" name="Picture 3" descr="E:\Belen2octubre2011\124NIKON\fotosmelontrilateralverano2008\FOTOSCDINRA\I156-S1A\DSCN2662.JPG"/>
            <p:cNvPicPr/>
            <p:nvPr/>
          </p:nvPicPr>
          <p:blipFill>
            <a:blip r:embed="rId3"/>
            <a:srcRect l="6628" t="0" r="0" b="11360"/>
            <a:stretch/>
          </p:blipFill>
          <p:spPr>
            <a:xfrm>
              <a:off x="6156000" y="549360"/>
              <a:ext cx="2230200" cy="158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4" name="Picture 4" descr="E:\Belen2octubre2011\124NIKON\fotosmelontrilateralverano2008\FOTOSCDINRA\I118-S2A\DSCN3653.JPG"/>
            <p:cNvPicPr/>
            <p:nvPr/>
          </p:nvPicPr>
          <p:blipFill>
            <a:blip r:embed="rId4"/>
            <a:srcRect l="1469" t="8605" r="1469" b="14132"/>
            <a:stretch/>
          </p:blipFill>
          <p:spPr>
            <a:xfrm>
              <a:off x="179280" y="2133000"/>
              <a:ext cx="2520360" cy="1500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5" name="Picture 5" descr="E:\Belen2octubre2011\124NIKON\fotosmelontrilateralverano2008\FOTOS FRUTOS PARA CD\C42-1A\DSCN0656.JPG"/>
            <p:cNvPicPr/>
            <p:nvPr/>
          </p:nvPicPr>
          <p:blipFill>
            <a:blip r:embed="rId5"/>
            <a:srcRect l="12826" t="3090" r="21094" b="9985"/>
            <a:stretch/>
          </p:blipFill>
          <p:spPr>
            <a:xfrm>
              <a:off x="2699640" y="2133000"/>
              <a:ext cx="1512000" cy="1487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6" name="Picture 6" descr="E:\Belen2octubre2011\124NIKON\fotosmelontrilateralverano2008\FOTOS FRUTOS PARA CD\C96-3A\DSCN1077.JPG"/>
            <p:cNvPicPr/>
            <p:nvPr/>
          </p:nvPicPr>
          <p:blipFill>
            <a:blip r:embed="rId6"/>
            <a:srcRect l="1475" t="4456" r="3537" b="26552"/>
            <a:stretch/>
          </p:blipFill>
          <p:spPr>
            <a:xfrm>
              <a:off x="4139640" y="2133000"/>
              <a:ext cx="2736360" cy="1486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7" name="Picture 7" descr="E:\Belen2octubre2011\124NIKON\fotosmelontrilateralverano2008\FOTOSCDINRA\I142-S2B\DSCN2571.JPG"/>
            <p:cNvPicPr/>
            <p:nvPr/>
          </p:nvPicPr>
          <p:blipFill>
            <a:blip r:embed="rId7"/>
            <a:srcRect l="27293" t="3092" r="8705" b="22406"/>
            <a:stretch/>
          </p:blipFill>
          <p:spPr>
            <a:xfrm>
              <a:off x="6804360" y="2133000"/>
              <a:ext cx="1584000" cy="1439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8" name="Picture 8" descr="E:\Belen2octubre2011\124NIKON\fotosmelontrilateralverano2008\FOTOS FRUTOS PARA CD\C87-S1A\DSCN2761.JPG"/>
            <p:cNvPicPr/>
            <p:nvPr/>
          </p:nvPicPr>
          <p:blipFill>
            <a:blip r:embed="rId8"/>
            <a:srcRect l="2497" t="14121" r="0" b="19640"/>
            <a:stretch/>
          </p:blipFill>
          <p:spPr>
            <a:xfrm>
              <a:off x="179280" y="3572640"/>
              <a:ext cx="2304360" cy="1244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9" name="Picture 9" descr="E:\Belen2octubre2011\124NIKON\fotosmelontrilateralverano2008\FOTOS FRUTOS PARA CD\C67´-1B\DSCN2072.JPG"/>
            <p:cNvPicPr/>
            <p:nvPr/>
          </p:nvPicPr>
          <p:blipFill>
            <a:blip r:embed="rId9"/>
            <a:srcRect l="5596" t="11359" r="0" b="19655"/>
            <a:stretch/>
          </p:blipFill>
          <p:spPr>
            <a:xfrm>
              <a:off x="4716000" y="3585600"/>
              <a:ext cx="2160360" cy="122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0" name="Picture 10" descr="E:\Belen2octubre2011\124NIKON\fotosmelontrilateralverano2008\FOTOS FRUTOS PARA CD\C85-S2A\DSCN2821.JPG"/>
            <p:cNvPicPr/>
            <p:nvPr/>
          </p:nvPicPr>
          <p:blipFill>
            <a:blip r:embed="rId10"/>
            <a:srcRect l="7665" t="8605" r="0" b="26543"/>
            <a:stretch/>
          </p:blipFill>
          <p:spPr>
            <a:xfrm>
              <a:off x="2483640" y="3572640"/>
              <a:ext cx="2232360" cy="1248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1" name="Picture 11" descr="E:\Belen2octubre2011\124NIKON\fotosmelontrilateralverano2008\FOTOSCDINRA\I122-1A\DSCN0414.JPG"/>
            <p:cNvPicPr/>
            <p:nvPr/>
          </p:nvPicPr>
          <p:blipFill>
            <a:blip r:embed="rId11"/>
            <a:srcRect l="12829" t="0" r="14896" b="15513"/>
            <a:stretch/>
          </p:blipFill>
          <p:spPr>
            <a:xfrm>
              <a:off x="6876360" y="3572640"/>
              <a:ext cx="1512000" cy="1223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2" name="16 CuadroTexto"/>
            <p:cNvSpPr/>
            <p:nvPr/>
          </p:nvSpPr>
          <p:spPr>
            <a:xfrm>
              <a:off x="179280" y="549360"/>
              <a:ext cx="418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37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17 CuadroTexto"/>
            <p:cNvSpPr/>
            <p:nvPr/>
          </p:nvSpPr>
          <p:spPr>
            <a:xfrm>
              <a:off x="2555640" y="2133000"/>
              <a:ext cx="418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4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18 CuadroTexto"/>
            <p:cNvSpPr/>
            <p:nvPr/>
          </p:nvSpPr>
          <p:spPr>
            <a:xfrm>
              <a:off x="4139640" y="2133000"/>
              <a:ext cx="418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4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19 CuadroTexto"/>
            <p:cNvSpPr/>
            <p:nvPr/>
          </p:nvSpPr>
          <p:spPr>
            <a:xfrm>
              <a:off x="6804360" y="2133000"/>
              <a:ext cx="418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4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20 CuadroTexto"/>
            <p:cNvSpPr/>
            <p:nvPr/>
          </p:nvSpPr>
          <p:spPr>
            <a:xfrm>
              <a:off x="179280" y="3572640"/>
              <a:ext cx="418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44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21 CuadroTexto"/>
            <p:cNvSpPr/>
            <p:nvPr/>
          </p:nvSpPr>
          <p:spPr>
            <a:xfrm>
              <a:off x="2483640" y="3572640"/>
              <a:ext cx="418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45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22 CuadroTexto"/>
            <p:cNvSpPr/>
            <p:nvPr/>
          </p:nvSpPr>
          <p:spPr>
            <a:xfrm>
              <a:off x="4716000" y="3572640"/>
              <a:ext cx="418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46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23 CuadroTexto"/>
            <p:cNvSpPr/>
            <p:nvPr/>
          </p:nvSpPr>
          <p:spPr>
            <a:xfrm>
              <a:off x="6804360" y="3572640"/>
              <a:ext cx="418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47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24 CuadroTexto"/>
            <p:cNvSpPr/>
            <p:nvPr/>
          </p:nvSpPr>
          <p:spPr>
            <a:xfrm>
              <a:off x="3131640" y="549360"/>
              <a:ext cx="418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38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25 CuadroTexto"/>
            <p:cNvSpPr/>
            <p:nvPr/>
          </p:nvSpPr>
          <p:spPr>
            <a:xfrm>
              <a:off x="6156000" y="549360"/>
              <a:ext cx="418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39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26 CuadroTexto"/>
            <p:cNvSpPr/>
            <p:nvPr/>
          </p:nvSpPr>
          <p:spPr>
            <a:xfrm>
              <a:off x="179280" y="2133000"/>
              <a:ext cx="418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4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" name="3 Rectángulo"/>
          <p:cNvSpPr/>
          <p:nvPr/>
        </p:nvSpPr>
        <p:spPr>
          <a:xfrm>
            <a:off x="214200" y="5286240"/>
            <a:ext cx="8358480" cy="10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ool 7: 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 inodorus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Spanish landrac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48-Cañadulce, 49-Erizo, 50-Amarillo oro, 51-Escrito oloroso, 52-Tendral, 53-Verde pinto, 54-Coca, 55-Mochuelo, 56-Largo de Villaconejos, 57-61-S. Fitó Amarillos (photo not included, phenotypically similar to 48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4" name="23 Grupo"/>
          <p:cNvGrpSpPr/>
          <p:nvPr/>
        </p:nvGrpSpPr>
        <p:grpSpPr>
          <a:xfrm>
            <a:off x="611280" y="404640"/>
            <a:ext cx="6697440" cy="4462560"/>
            <a:chOff x="611280" y="404640"/>
            <a:chExt cx="6697440" cy="4462560"/>
          </a:xfrm>
        </p:grpSpPr>
        <p:pic>
          <p:nvPicPr>
            <p:cNvPr id="145" name="Picture 1" descr="E:\Belen2octubre2011\124NIKON\fotosmelontrilateralverano2008\FOTOS FRUTOS PARA CD\C48-3A\DSCN1432.JPG"/>
            <p:cNvPicPr/>
            <p:nvPr/>
          </p:nvPicPr>
          <p:blipFill>
            <a:blip r:embed="rId1"/>
            <a:srcRect l="2509" t="8600" r="5600" b="15509"/>
            <a:stretch/>
          </p:blipFill>
          <p:spPr>
            <a:xfrm>
              <a:off x="611280" y="417240"/>
              <a:ext cx="2214000" cy="1357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6" name="Picture 2" descr="E:\Belen2octubre2011\124NIKON\fotosmelontrilateralverano2008\FOTOS FRUTOS PARA CD\C75-1A\DSCN1364.JPG"/>
            <p:cNvPicPr/>
            <p:nvPr/>
          </p:nvPicPr>
          <p:blipFill>
            <a:blip r:embed="rId2"/>
            <a:srcRect l="3542" t="14120" r="1476" b="21017"/>
            <a:stretch/>
          </p:blipFill>
          <p:spPr>
            <a:xfrm>
              <a:off x="2771640" y="417240"/>
              <a:ext cx="2664360" cy="1429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7" name="Picture 3" descr="E:\Belen2octubre2011\124NIKON\fotosmelontrilateralverano2008\FOTOS FRUTOS PARA CD\C79-2A\DSCN1631.JPG"/>
            <p:cNvPicPr/>
            <p:nvPr/>
          </p:nvPicPr>
          <p:blipFill>
            <a:blip r:embed="rId3"/>
            <a:srcRect l="9729" t="7218" r="8693" b="11366"/>
            <a:stretch/>
          </p:blipFill>
          <p:spPr>
            <a:xfrm>
              <a:off x="5436360" y="417240"/>
              <a:ext cx="1872360" cy="1429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8" name="Picture 4" descr="E:\Belen2octubre2011\124NIKON\fotosmelontrilateralverano2008\FOTOS FRUTOS PARA CD\C50-S1A\DSCN3055.JPG"/>
            <p:cNvPicPr/>
            <p:nvPr/>
          </p:nvPicPr>
          <p:blipFill>
            <a:blip r:embed="rId4"/>
            <a:srcRect l="0" t="12739" r="0" b="8607"/>
            <a:stretch/>
          </p:blipFill>
          <p:spPr>
            <a:xfrm>
              <a:off x="611280" y="1772640"/>
              <a:ext cx="2664360" cy="1556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9" name="Picture 5" descr="E:\Belen2octubre2011\124NIKON\fotosmelontrilateralverano2008\FOTOS FRUTOS PARA CD\C59-S3A\DSCN3897.JPG"/>
            <p:cNvPicPr/>
            <p:nvPr/>
          </p:nvPicPr>
          <p:blipFill>
            <a:blip r:embed="rId5"/>
            <a:srcRect l="7670" t="8470" r="5593" b="11370"/>
            <a:stretch/>
          </p:blipFill>
          <p:spPr>
            <a:xfrm>
              <a:off x="3203640" y="1844640"/>
              <a:ext cx="2016360" cy="1500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0" name="Picture 6" descr="E:\Belen2octubre2011\124NIKON\fotosmelontrilateralverano2008\FOTOS FRUTOS PARA CD\C73-S1A\DSCN2607.JPG"/>
            <p:cNvPicPr/>
            <p:nvPr/>
          </p:nvPicPr>
          <p:blipFill>
            <a:blip r:embed="rId6"/>
            <a:srcRect l="5604" t="5849" r="6628" b="12752"/>
            <a:stretch/>
          </p:blipFill>
          <p:spPr>
            <a:xfrm>
              <a:off x="5148360" y="1844640"/>
              <a:ext cx="2160360" cy="1572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1" name="Picture 7" descr="E:\Belen2octubre2011\124NIKON\fotosmelontrilateralverano2008\FOTOS FRUTOS PARA CD\C49-S1A\DSCN3048.JPG"/>
            <p:cNvPicPr/>
            <p:nvPr/>
          </p:nvPicPr>
          <p:blipFill>
            <a:blip r:embed="rId7"/>
            <a:srcRect l="7661" t="1698" r="0" b="22401"/>
            <a:stretch/>
          </p:blipFill>
          <p:spPr>
            <a:xfrm>
              <a:off x="611280" y="3285000"/>
              <a:ext cx="2592360" cy="1582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2" name="Picture 8" descr="E:\Belen2octubre2011\124NIKON\fotosmelontrilateralverano2008\FOTOS FRUTOS PARA CD\C68´-S3A\DSCN3878.JPG"/>
            <p:cNvPicPr/>
            <p:nvPr/>
          </p:nvPicPr>
          <p:blipFill>
            <a:blip r:embed="rId8"/>
            <a:srcRect l="0" t="7227" r="0" b="9976"/>
            <a:stretch/>
          </p:blipFill>
          <p:spPr>
            <a:xfrm>
              <a:off x="3203640" y="3344040"/>
              <a:ext cx="2448360" cy="1505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3" name="Picture 9" descr="E:\Belen2octubre2011\124NIKON\fotosmelontrilateralverano2008\FOTOS FRUTOS PARA CD\C69-S1A\DSCN3951.JPG"/>
            <p:cNvPicPr/>
            <p:nvPr/>
          </p:nvPicPr>
          <p:blipFill>
            <a:blip r:embed="rId9"/>
            <a:srcRect l="11364" t="0" r="16363" b="5834"/>
            <a:stretch/>
          </p:blipFill>
          <p:spPr>
            <a:xfrm>
              <a:off x="5652360" y="3357000"/>
              <a:ext cx="1656360" cy="1500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4" name="14 CuadroTexto"/>
            <p:cNvSpPr/>
            <p:nvPr/>
          </p:nvSpPr>
          <p:spPr>
            <a:xfrm>
              <a:off x="611280" y="404640"/>
              <a:ext cx="418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48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15 CuadroTexto"/>
            <p:cNvSpPr/>
            <p:nvPr/>
          </p:nvSpPr>
          <p:spPr>
            <a:xfrm>
              <a:off x="2771640" y="404640"/>
              <a:ext cx="418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49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16 CuadroTexto"/>
            <p:cNvSpPr/>
            <p:nvPr/>
          </p:nvSpPr>
          <p:spPr>
            <a:xfrm>
              <a:off x="3203640" y="3357000"/>
              <a:ext cx="418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55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17 CuadroTexto"/>
            <p:cNvSpPr/>
            <p:nvPr/>
          </p:nvSpPr>
          <p:spPr>
            <a:xfrm>
              <a:off x="611280" y="3285000"/>
              <a:ext cx="418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54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18 CuadroTexto"/>
            <p:cNvSpPr/>
            <p:nvPr/>
          </p:nvSpPr>
          <p:spPr>
            <a:xfrm>
              <a:off x="611280" y="1700640"/>
              <a:ext cx="418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5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19 CuadroTexto"/>
            <p:cNvSpPr/>
            <p:nvPr/>
          </p:nvSpPr>
          <p:spPr>
            <a:xfrm>
              <a:off x="3203640" y="1772640"/>
              <a:ext cx="418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5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20 CuadroTexto"/>
            <p:cNvSpPr/>
            <p:nvPr/>
          </p:nvSpPr>
          <p:spPr>
            <a:xfrm>
              <a:off x="5148360" y="1844640"/>
              <a:ext cx="418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5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21 CuadroTexto"/>
            <p:cNvSpPr/>
            <p:nvPr/>
          </p:nvSpPr>
          <p:spPr>
            <a:xfrm>
              <a:off x="5436360" y="404640"/>
              <a:ext cx="418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5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22 CuadroTexto"/>
            <p:cNvSpPr/>
            <p:nvPr/>
          </p:nvSpPr>
          <p:spPr>
            <a:xfrm>
              <a:off x="5652360" y="3357000"/>
              <a:ext cx="418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56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" name="3 Rectángulo"/>
          <p:cNvSpPr/>
          <p:nvPr/>
        </p:nvSpPr>
        <p:spPr>
          <a:xfrm>
            <a:off x="1214280" y="5000760"/>
            <a:ext cx="6357960" cy="855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ool 8: 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inodorus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group market class Piel de sapo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62-T111, 63-67 S.Fitó Piel de sapo (photo corresponds to T111, the other Piel de sapo are phenotypically similar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4" name="6 Grupo"/>
          <p:cNvGrpSpPr/>
          <p:nvPr/>
        </p:nvGrpSpPr>
        <p:grpSpPr>
          <a:xfrm>
            <a:off x="1908000" y="1123920"/>
            <a:ext cx="4176720" cy="3583080"/>
            <a:chOff x="1908000" y="1123920"/>
            <a:chExt cx="4176720" cy="3583080"/>
          </a:xfrm>
        </p:grpSpPr>
        <p:pic>
          <p:nvPicPr>
            <p:cNvPr id="165" name="Picture 49" descr="C:\users\belen\documents\fotosmelontrilateralverano2008\fotos frutos para cd\c61´-s3a\DSCN3972.JPG"/>
            <p:cNvPicPr/>
            <p:nvPr/>
          </p:nvPicPr>
          <p:blipFill>
            <a:blip r:embed="rId1"/>
            <a:srcRect l="13939" t="2896" r="13321" b="13868"/>
            <a:stretch/>
          </p:blipFill>
          <p:spPr>
            <a:xfrm>
              <a:off x="1908000" y="1123920"/>
              <a:ext cx="4176720" cy="3583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66" name="5 CuadroTexto"/>
            <p:cNvSpPr/>
            <p:nvPr/>
          </p:nvSpPr>
          <p:spPr>
            <a:xfrm>
              <a:off x="1908000" y="1195920"/>
              <a:ext cx="792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800" spc="-1" strike="noStrike">
                  <a:solidFill>
                    <a:srgbClr val="ffffff"/>
                  </a:solidFill>
                  <a:latin typeface="Calibri"/>
                </a:rPr>
                <a:t>62-67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0-28T09:09:53Z</dcterms:created>
  <dc:creator>Belen</dc:creator>
  <dc:description/>
  <dc:language>en-US</dc:language>
  <cp:lastModifiedBy>Belen</cp:lastModifiedBy>
  <dcterms:modified xsi:type="dcterms:W3CDTF">2012-04-20T20:24:28Z</dcterms:modified>
  <cp:revision>24</cp:revision>
  <dc:subject/>
  <dc:title>Diapositiva 1</dc:title>
</cp:coreProperties>
</file>